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5" autoAdjust="0"/>
    <p:restoredTop sz="94617"/>
  </p:normalViewPr>
  <p:slideViewPr>
    <p:cSldViewPr snapToGrid="0">
      <p:cViewPr varScale="1">
        <p:scale>
          <a:sx n="104" d="100"/>
          <a:sy n="104" d="100"/>
        </p:scale>
        <p:origin x="87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&#35542;&#25991;\&#26657;&#27491;&#24460;\DK%20DKA%20HH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&#35542;&#25991;\&#26657;&#27491;&#24460;\DK%20DKA%20HH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atsuya%20Iida\Desktop\&#12464;&#12523;&#12459;&#12468;&#12531;\new%20DK%20DK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atsuya%20Iida\Desktop\&#12464;&#12523;&#12459;&#12468;&#12531;\new%20DK%20DK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DK!$BO$1</c:f>
              <c:strCache>
                <c:ptCount val="1"/>
                <c:pt idx="0">
                  <c:v>ｐ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K!$Z$2:$Z$58</c:f>
              <c:numCache>
                <c:formatCode>General</c:formatCode>
                <c:ptCount val="57"/>
                <c:pt idx="0">
                  <c:v>7177</c:v>
                </c:pt>
                <c:pt idx="2">
                  <c:v>3986</c:v>
                </c:pt>
                <c:pt idx="3">
                  <c:v>626</c:v>
                </c:pt>
                <c:pt idx="4">
                  <c:v>5705</c:v>
                </c:pt>
                <c:pt idx="5">
                  <c:v>3395</c:v>
                </c:pt>
                <c:pt idx="6">
                  <c:v>2105</c:v>
                </c:pt>
                <c:pt idx="7">
                  <c:v>2930</c:v>
                </c:pt>
                <c:pt idx="8">
                  <c:v>1409</c:v>
                </c:pt>
                <c:pt idx="9">
                  <c:v>815</c:v>
                </c:pt>
                <c:pt idx="10">
                  <c:v>972</c:v>
                </c:pt>
                <c:pt idx="11">
                  <c:v>2705</c:v>
                </c:pt>
                <c:pt idx="12">
                  <c:v>1327</c:v>
                </c:pt>
                <c:pt idx="13">
                  <c:v>5783</c:v>
                </c:pt>
                <c:pt idx="14">
                  <c:v>836</c:v>
                </c:pt>
                <c:pt idx="15">
                  <c:v>1159</c:v>
                </c:pt>
                <c:pt idx="16">
                  <c:v>820</c:v>
                </c:pt>
                <c:pt idx="17">
                  <c:v>1612</c:v>
                </c:pt>
                <c:pt idx="18">
                  <c:v>1011</c:v>
                </c:pt>
                <c:pt idx="19">
                  <c:v>152</c:v>
                </c:pt>
                <c:pt idx="20">
                  <c:v>6224</c:v>
                </c:pt>
                <c:pt idx="21">
                  <c:v>8524</c:v>
                </c:pt>
                <c:pt idx="22">
                  <c:v>738</c:v>
                </c:pt>
                <c:pt idx="23">
                  <c:v>6602</c:v>
                </c:pt>
                <c:pt idx="24">
                  <c:v>1411</c:v>
                </c:pt>
                <c:pt idx="25">
                  <c:v>12065</c:v>
                </c:pt>
                <c:pt idx="26">
                  <c:v>6866</c:v>
                </c:pt>
                <c:pt idx="27">
                  <c:v>323</c:v>
                </c:pt>
                <c:pt idx="28">
                  <c:v>411</c:v>
                </c:pt>
                <c:pt idx="29">
                  <c:v>4793</c:v>
                </c:pt>
                <c:pt idx="30">
                  <c:v>4667</c:v>
                </c:pt>
                <c:pt idx="31">
                  <c:v>5612</c:v>
                </c:pt>
                <c:pt idx="32">
                  <c:v>4928</c:v>
                </c:pt>
                <c:pt idx="33">
                  <c:v>10973</c:v>
                </c:pt>
                <c:pt idx="34">
                  <c:v>10605</c:v>
                </c:pt>
                <c:pt idx="35">
                  <c:v>2918</c:v>
                </c:pt>
                <c:pt idx="36">
                  <c:v>1145</c:v>
                </c:pt>
                <c:pt idx="37">
                  <c:v>6410</c:v>
                </c:pt>
                <c:pt idx="38">
                  <c:v>1415</c:v>
                </c:pt>
                <c:pt idx="39">
                  <c:v>893</c:v>
                </c:pt>
                <c:pt idx="40">
                  <c:v>1274</c:v>
                </c:pt>
                <c:pt idx="41">
                  <c:v>1817</c:v>
                </c:pt>
                <c:pt idx="42">
                  <c:v>9948</c:v>
                </c:pt>
                <c:pt idx="43">
                  <c:v>483</c:v>
                </c:pt>
                <c:pt idx="44">
                  <c:v>933</c:v>
                </c:pt>
                <c:pt idx="45">
                  <c:v>4265</c:v>
                </c:pt>
                <c:pt idx="46">
                  <c:v>7970</c:v>
                </c:pt>
                <c:pt idx="47">
                  <c:v>2485</c:v>
                </c:pt>
                <c:pt idx="48">
                  <c:v>6701</c:v>
                </c:pt>
                <c:pt idx="49">
                  <c:v>945</c:v>
                </c:pt>
                <c:pt idx="50">
                  <c:v>9700</c:v>
                </c:pt>
                <c:pt idx="51">
                  <c:v>7914</c:v>
                </c:pt>
                <c:pt idx="52">
                  <c:v>2660</c:v>
                </c:pt>
                <c:pt idx="53">
                  <c:v>720</c:v>
                </c:pt>
                <c:pt idx="54">
                  <c:v>13277</c:v>
                </c:pt>
              </c:numCache>
            </c:numRef>
          </c:xVal>
          <c:yVal>
            <c:numRef>
              <c:f>DK!$BR$2:$BR$58</c:f>
              <c:numCache>
                <c:formatCode>General</c:formatCode>
                <c:ptCount val="57"/>
                <c:pt idx="0">
                  <c:v>20.8</c:v>
                </c:pt>
                <c:pt idx="2">
                  <c:v>19.899999999999999</c:v>
                </c:pt>
                <c:pt idx="4">
                  <c:v>21.8</c:v>
                </c:pt>
                <c:pt idx="5">
                  <c:v>27.1</c:v>
                </c:pt>
                <c:pt idx="6">
                  <c:v>26.6</c:v>
                </c:pt>
                <c:pt idx="7">
                  <c:v>22</c:v>
                </c:pt>
                <c:pt idx="8">
                  <c:v>23.2</c:v>
                </c:pt>
                <c:pt idx="9">
                  <c:v>24.2</c:v>
                </c:pt>
                <c:pt idx="10">
                  <c:v>23.7</c:v>
                </c:pt>
                <c:pt idx="11">
                  <c:v>20.2</c:v>
                </c:pt>
                <c:pt idx="12">
                  <c:v>22</c:v>
                </c:pt>
                <c:pt idx="13">
                  <c:v>17.100000000000001</c:v>
                </c:pt>
                <c:pt idx="14">
                  <c:v>21.4</c:v>
                </c:pt>
                <c:pt idx="15">
                  <c:v>26.2</c:v>
                </c:pt>
                <c:pt idx="16">
                  <c:v>26.8</c:v>
                </c:pt>
                <c:pt idx="17">
                  <c:v>24.6</c:v>
                </c:pt>
                <c:pt idx="18">
                  <c:v>23</c:v>
                </c:pt>
                <c:pt idx="19">
                  <c:v>23.3</c:v>
                </c:pt>
                <c:pt idx="20">
                  <c:v>23.7</c:v>
                </c:pt>
                <c:pt idx="21">
                  <c:v>10.9</c:v>
                </c:pt>
                <c:pt idx="22">
                  <c:v>25.9</c:v>
                </c:pt>
                <c:pt idx="23">
                  <c:v>15.9</c:v>
                </c:pt>
                <c:pt idx="24">
                  <c:v>21.8</c:v>
                </c:pt>
                <c:pt idx="25">
                  <c:v>13</c:v>
                </c:pt>
                <c:pt idx="26">
                  <c:v>18.8</c:v>
                </c:pt>
                <c:pt idx="27">
                  <c:v>23</c:v>
                </c:pt>
                <c:pt idx="28">
                  <c:v>27.7</c:v>
                </c:pt>
                <c:pt idx="29">
                  <c:v>16.899999999999999</c:v>
                </c:pt>
                <c:pt idx="30">
                  <c:v>20.5</c:v>
                </c:pt>
                <c:pt idx="32">
                  <c:v>21.9</c:v>
                </c:pt>
                <c:pt idx="33">
                  <c:v>13.8</c:v>
                </c:pt>
                <c:pt idx="34">
                  <c:v>16.7</c:v>
                </c:pt>
                <c:pt idx="35">
                  <c:v>21.2</c:v>
                </c:pt>
                <c:pt idx="36">
                  <c:v>24.6</c:v>
                </c:pt>
                <c:pt idx="37">
                  <c:v>19.899999999999999</c:v>
                </c:pt>
                <c:pt idx="38">
                  <c:v>22.5</c:v>
                </c:pt>
                <c:pt idx="39">
                  <c:v>18.2</c:v>
                </c:pt>
                <c:pt idx="40">
                  <c:v>32.5</c:v>
                </c:pt>
                <c:pt idx="41">
                  <c:v>23.6</c:v>
                </c:pt>
                <c:pt idx="42">
                  <c:v>20</c:v>
                </c:pt>
                <c:pt idx="44">
                  <c:v>24.5</c:v>
                </c:pt>
                <c:pt idx="45">
                  <c:v>22.1</c:v>
                </c:pt>
                <c:pt idx="46">
                  <c:v>19.899999999999999</c:v>
                </c:pt>
                <c:pt idx="49">
                  <c:v>25.1</c:v>
                </c:pt>
                <c:pt idx="50">
                  <c:v>19.100000000000001</c:v>
                </c:pt>
                <c:pt idx="51">
                  <c:v>12.2</c:v>
                </c:pt>
                <c:pt idx="52">
                  <c:v>19.3</c:v>
                </c:pt>
                <c:pt idx="53">
                  <c:v>25.8</c:v>
                </c:pt>
                <c:pt idx="54">
                  <c:v>1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ECE-4ED9-90A2-1944A73D83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9583104"/>
        <c:axId val="1899577824"/>
      </c:scatterChart>
      <c:valAx>
        <c:axId val="1899583104"/>
        <c:scaling>
          <c:orientation val="minMax"/>
          <c:max val="2500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noFill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1899577824"/>
        <c:crosses val="autoZero"/>
        <c:crossBetween val="midCat"/>
      </c:valAx>
      <c:valAx>
        <c:axId val="18995778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noFill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18995831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600">
          <a:latin typeface="Calibri" panose="020F0502020204030204" pitchFamily="34" charset="0"/>
          <a:ea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DKA!$BO$1</c:f>
              <c:strCache>
                <c:ptCount val="1"/>
                <c:pt idx="0">
                  <c:v>ｐ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DKA!$Z$2:$Z$40</c:f>
              <c:numCache>
                <c:formatCode>General</c:formatCode>
                <c:ptCount val="39"/>
                <c:pt idx="0">
                  <c:v>11506</c:v>
                </c:pt>
                <c:pt idx="1">
                  <c:v>13319</c:v>
                </c:pt>
                <c:pt idx="2">
                  <c:v>9871</c:v>
                </c:pt>
                <c:pt idx="3">
                  <c:v>9433</c:v>
                </c:pt>
                <c:pt idx="4">
                  <c:v>15964</c:v>
                </c:pt>
                <c:pt idx="5">
                  <c:v>13940</c:v>
                </c:pt>
                <c:pt idx="6">
                  <c:v>14942</c:v>
                </c:pt>
                <c:pt idx="7">
                  <c:v>10345</c:v>
                </c:pt>
                <c:pt idx="8">
                  <c:v>4928</c:v>
                </c:pt>
                <c:pt idx="9">
                  <c:v>10535</c:v>
                </c:pt>
                <c:pt idx="10">
                  <c:v>4133</c:v>
                </c:pt>
                <c:pt idx="11">
                  <c:v>14742</c:v>
                </c:pt>
                <c:pt idx="12">
                  <c:v>3837</c:v>
                </c:pt>
                <c:pt idx="13">
                  <c:v>6382</c:v>
                </c:pt>
                <c:pt idx="14">
                  <c:v>11005</c:v>
                </c:pt>
                <c:pt idx="15">
                  <c:v>16769</c:v>
                </c:pt>
                <c:pt idx="16">
                  <c:v>7833</c:v>
                </c:pt>
                <c:pt idx="17">
                  <c:v>3445</c:v>
                </c:pt>
                <c:pt idx="18">
                  <c:v>4288</c:v>
                </c:pt>
                <c:pt idx="19">
                  <c:v>23540</c:v>
                </c:pt>
                <c:pt idx="20">
                  <c:v>4459</c:v>
                </c:pt>
                <c:pt idx="21">
                  <c:v>14267</c:v>
                </c:pt>
                <c:pt idx="22">
                  <c:v>14546</c:v>
                </c:pt>
                <c:pt idx="23">
                  <c:v>15608</c:v>
                </c:pt>
                <c:pt idx="24">
                  <c:v>15253</c:v>
                </c:pt>
                <c:pt idx="25">
                  <c:v>15210</c:v>
                </c:pt>
                <c:pt idx="26">
                  <c:v>12434</c:v>
                </c:pt>
                <c:pt idx="27">
                  <c:v>15810</c:v>
                </c:pt>
                <c:pt idx="28">
                  <c:v>8908</c:v>
                </c:pt>
                <c:pt idx="29">
                  <c:v>16310</c:v>
                </c:pt>
                <c:pt idx="30">
                  <c:v>7436</c:v>
                </c:pt>
                <c:pt idx="31">
                  <c:v>14185</c:v>
                </c:pt>
                <c:pt idx="32">
                  <c:v>14565</c:v>
                </c:pt>
                <c:pt idx="33">
                  <c:v>20387</c:v>
                </c:pt>
                <c:pt idx="34">
                  <c:v>11280</c:v>
                </c:pt>
                <c:pt idx="35">
                  <c:v>13061</c:v>
                </c:pt>
                <c:pt idx="36">
                  <c:v>17871</c:v>
                </c:pt>
              </c:numCache>
            </c:numRef>
          </c:xVal>
          <c:yVal>
            <c:numRef>
              <c:f>DKA!$BR$2:$BR$40</c:f>
              <c:numCache>
                <c:formatCode>General</c:formatCode>
                <c:ptCount val="39"/>
                <c:pt idx="0">
                  <c:v>6.8</c:v>
                </c:pt>
                <c:pt idx="1">
                  <c:v>1.9</c:v>
                </c:pt>
                <c:pt idx="2">
                  <c:v>4.5</c:v>
                </c:pt>
                <c:pt idx="3">
                  <c:v>13.4</c:v>
                </c:pt>
                <c:pt idx="4">
                  <c:v>3.8</c:v>
                </c:pt>
                <c:pt idx="5">
                  <c:v>1.7</c:v>
                </c:pt>
                <c:pt idx="6">
                  <c:v>4</c:v>
                </c:pt>
                <c:pt idx="7">
                  <c:v>7.1</c:v>
                </c:pt>
                <c:pt idx="8">
                  <c:v>21.5</c:v>
                </c:pt>
                <c:pt idx="9">
                  <c:v>8.8000000000000007</c:v>
                </c:pt>
                <c:pt idx="10">
                  <c:v>17.399999999999999</c:v>
                </c:pt>
                <c:pt idx="11">
                  <c:v>13</c:v>
                </c:pt>
                <c:pt idx="12">
                  <c:v>20.7</c:v>
                </c:pt>
                <c:pt idx="13">
                  <c:v>16.7</c:v>
                </c:pt>
                <c:pt idx="14">
                  <c:v>9.8000000000000007</c:v>
                </c:pt>
                <c:pt idx="15">
                  <c:v>8.1999999999999993</c:v>
                </c:pt>
                <c:pt idx="16">
                  <c:v>17.8</c:v>
                </c:pt>
                <c:pt idx="17">
                  <c:v>19.399999999999999</c:v>
                </c:pt>
                <c:pt idx="18">
                  <c:v>19.600000000000001</c:v>
                </c:pt>
                <c:pt idx="19">
                  <c:v>8.1</c:v>
                </c:pt>
                <c:pt idx="20">
                  <c:v>15.4</c:v>
                </c:pt>
                <c:pt idx="21">
                  <c:v>6.4</c:v>
                </c:pt>
                <c:pt idx="22">
                  <c:v>13.9</c:v>
                </c:pt>
                <c:pt idx="23">
                  <c:v>10.5</c:v>
                </c:pt>
                <c:pt idx="24">
                  <c:v>4.3</c:v>
                </c:pt>
                <c:pt idx="25">
                  <c:v>11.9</c:v>
                </c:pt>
                <c:pt idx="26">
                  <c:v>4.7</c:v>
                </c:pt>
                <c:pt idx="27">
                  <c:v>2</c:v>
                </c:pt>
                <c:pt idx="28">
                  <c:v>8.8000000000000007</c:v>
                </c:pt>
                <c:pt idx="29">
                  <c:v>11.7</c:v>
                </c:pt>
                <c:pt idx="30">
                  <c:v>13.6</c:v>
                </c:pt>
                <c:pt idx="31">
                  <c:v>6.4</c:v>
                </c:pt>
                <c:pt idx="32">
                  <c:v>8.5</c:v>
                </c:pt>
                <c:pt idx="33">
                  <c:v>4.3</c:v>
                </c:pt>
                <c:pt idx="34">
                  <c:v>14.5</c:v>
                </c:pt>
                <c:pt idx="35">
                  <c:v>1.2</c:v>
                </c:pt>
                <c:pt idx="36">
                  <c:v>4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6C0-4592-B834-33C84429FF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9591744"/>
        <c:axId val="1899596544"/>
      </c:scatterChart>
      <c:valAx>
        <c:axId val="1899591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1899596544"/>
        <c:crosses val="autoZero"/>
        <c:crossBetween val="midCat"/>
      </c:valAx>
      <c:valAx>
        <c:axId val="1899596544"/>
        <c:scaling>
          <c:orientation val="minMax"/>
          <c:max val="35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18995917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600">
          <a:latin typeface="Calibri" panose="020F0502020204030204" pitchFamily="34" charset="0"/>
          <a:ea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DK!$BO$1</c:f>
              <c:strCache>
                <c:ptCount val="1"/>
                <c:pt idx="0">
                  <c:v>ｐ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K!$Z$2:$Z$58</c:f>
              <c:numCache>
                <c:formatCode>General</c:formatCode>
                <c:ptCount val="57"/>
                <c:pt idx="0">
                  <c:v>7177</c:v>
                </c:pt>
                <c:pt idx="2">
                  <c:v>3986</c:v>
                </c:pt>
                <c:pt idx="3">
                  <c:v>626</c:v>
                </c:pt>
                <c:pt idx="4">
                  <c:v>5705</c:v>
                </c:pt>
                <c:pt idx="5">
                  <c:v>3395</c:v>
                </c:pt>
                <c:pt idx="6">
                  <c:v>2105</c:v>
                </c:pt>
                <c:pt idx="7">
                  <c:v>2930</c:v>
                </c:pt>
                <c:pt idx="8">
                  <c:v>1409</c:v>
                </c:pt>
                <c:pt idx="9">
                  <c:v>815</c:v>
                </c:pt>
                <c:pt idx="10">
                  <c:v>972</c:v>
                </c:pt>
                <c:pt idx="11">
                  <c:v>2705</c:v>
                </c:pt>
                <c:pt idx="12">
                  <c:v>1327</c:v>
                </c:pt>
                <c:pt idx="13">
                  <c:v>5783</c:v>
                </c:pt>
                <c:pt idx="14">
                  <c:v>836</c:v>
                </c:pt>
                <c:pt idx="15">
                  <c:v>1159</c:v>
                </c:pt>
                <c:pt idx="16">
                  <c:v>820</c:v>
                </c:pt>
                <c:pt idx="17">
                  <c:v>1612</c:v>
                </c:pt>
                <c:pt idx="18">
                  <c:v>1011</c:v>
                </c:pt>
                <c:pt idx="19">
                  <c:v>152</c:v>
                </c:pt>
                <c:pt idx="20">
                  <c:v>6224</c:v>
                </c:pt>
                <c:pt idx="21">
                  <c:v>8524</c:v>
                </c:pt>
                <c:pt idx="22">
                  <c:v>738</c:v>
                </c:pt>
                <c:pt idx="23">
                  <c:v>6602</c:v>
                </c:pt>
                <c:pt idx="24">
                  <c:v>1411</c:v>
                </c:pt>
                <c:pt idx="25">
                  <c:v>12065</c:v>
                </c:pt>
                <c:pt idx="26">
                  <c:v>6866</c:v>
                </c:pt>
                <c:pt idx="27">
                  <c:v>323</c:v>
                </c:pt>
                <c:pt idx="28">
                  <c:v>411</c:v>
                </c:pt>
                <c:pt idx="29">
                  <c:v>4793</c:v>
                </c:pt>
                <c:pt idx="30">
                  <c:v>4667</c:v>
                </c:pt>
                <c:pt idx="31">
                  <c:v>5612</c:v>
                </c:pt>
                <c:pt idx="32">
                  <c:v>4928</c:v>
                </c:pt>
                <c:pt idx="33">
                  <c:v>10973</c:v>
                </c:pt>
                <c:pt idx="34">
                  <c:v>10605</c:v>
                </c:pt>
                <c:pt idx="35">
                  <c:v>2918</c:v>
                </c:pt>
                <c:pt idx="36">
                  <c:v>1145</c:v>
                </c:pt>
                <c:pt idx="37">
                  <c:v>6410</c:v>
                </c:pt>
                <c:pt idx="38">
                  <c:v>1415</c:v>
                </c:pt>
                <c:pt idx="39">
                  <c:v>893</c:v>
                </c:pt>
                <c:pt idx="40">
                  <c:v>1274</c:v>
                </c:pt>
                <c:pt idx="41">
                  <c:v>1817</c:v>
                </c:pt>
                <c:pt idx="42">
                  <c:v>9948</c:v>
                </c:pt>
                <c:pt idx="43">
                  <c:v>483</c:v>
                </c:pt>
                <c:pt idx="44">
                  <c:v>933</c:v>
                </c:pt>
                <c:pt idx="45">
                  <c:v>4265</c:v>
                </c:pt>
                <c:pt idx="46">
                  <c:v>7970</c:v>
                </c:pt>
                <c:pt idx="47">
                  <c:v>2485</c:v>
                </c:pt>
                <c:pt idx="48">
                  <c:v>6701</c:v>
                </c:pt>
                <c:pt idx="49">
                  <c:v>945</c:v>
                </c:pt>
                <c:pt idx="50">
                  <c:v>9700</c:v>
                </c:pt>
                <c:pt idx="51">
                  <c:v>7914</c:v>
                </c:pt>
                <c:pt idx="52">
                  <c:v>2660</c:v>
                </c:pt>
                <c:pt idx="53">
                  <c:v>720</c:v>
                </c:pt>
                <c:pt idx="54">
                  <c:v>13277</c:v>
                </c:pt>
              </c:numCache>
            </c:numRef>
          </c:xVal>
          <c:yVal>
            <c:numRef>
              <c:f>DK!$BS$2:$BS$58</c:f>
              <c:numCache>
                <c:formatCode>General</c:formatCode>
                <c:ptCount val="57"/>
                <c:pt idx="0">
                  <c:v>14.9</c:v>
                </c:pt>
                <c:pt idx="2">
                  <c:v>17</c:v>
                </c:pt>
                <c:pt idx="4">
                  <c:v>15.3</c:v>
                </c:pt>
                <c:pt idx="5">
                  <c:v>14.5</c:v>
                </c:pt>
                <c:pt idx="6">
                  <c:v>10.3</c:v>
                </c:pt>
                <c:pt idx="7">
                  <c:v>9.6999999999999993</c:v>
                </c:pt>
                <c:pt idx="8">
                  <c:v>12.1</c:v>
                </c:pt>
                <c:pt idx="9">
                  <c:v>13.9</c:v>
                </c:pt>
                <c:pt idx="10">
                  <c:v>13.4</c:v>
                </c:pt>
                <c:pt idx="11">
                  <c:v>13.7</c:v>
                </c:pt>
                <c:pt idx="12">
                  <c:v>15.3</c:v>
                </c:pt>
                <c:pt idx="13">
                  <c:v>21.3</c:v>
                </c:pt>
                <c:pt idx="14">
                  <c:v>13.2</c:v>
                </c:pt>
                <c:pt idx="15">
                  <c:v>14.2</c:v>
                </c:pt>
                <c:pt idx="16">
                  <c:v>11.5</c:v>
                </c:pt>
                <c:pt idx="17">
                  <c:v>15.2</c:v>
                </c:pt>
                <c:pt idx="18">
                  <c:v>12.2</c:v>
                </c:pt>
                <c:pt idx="19">
                  <c:v>14.1</c:v>
                </c:pt>
                <c:pt idx="20">
                  <c:v>13.3</c:v>
                </c:pt>
                <c:pt idx="21">
                  <c:v>21.4</c:v>
                </c:pt>
                <c:pt idx="22">
                  <c:v>11.4</c:v>
                </c:pt>
                <c:pt idx="23">
                  <c:v>22.6</c:v>
                </c:pt>
                <c:pt idx="24">
                  <c:v>15.7</c:v>
                </c:pt>
                <c:pt idx="25">
                  <c:v>24.1</c:v>
                </c:pt>
                <c:pt idx="26">
                  <c:v>22.4</c:v>
                </c:pt>
                <c:pt idx="27">
                  <c:v>15.8</c:v>
                </c:pt>
                <c:pt idx="28">
                  <c:v>12.5</c:v>
                </c:pt>
                <c:pt idx="29">
                  <c:v>17.5</c:v>
                </c:pt>
                <c:pt idx="30">
                  <c:v>20</c:v>
                </c:pt>
                <c:pt idx="32">
                  <c:v>14.7</c:v>
                </c:pt>
                <c:pt idx="33">
                  <c:v>22.8</c:v>
                </c:pt>
                <c:pt idx="34">
                  <c:v>23.6</c:v>
                </c:pt>
                <c:pt idx="35">
                  <c:v>16</c:v>
                </c:pt>
                <c:pt idx="36">
                  <c:v>7.7</c:v>
                </c:pt>
                <c:pt idx="37">
                  <c:v>19.100000000000001</c:v>
                </c:pt>
                <c:pt idx="38">
                  <c:v>14</c:v>
                </c:pt>
                <c:pt idx="39">
                  <c:v>20.8</c:v>
                </c:pt>
                <c:pt idx="40">
                  <c:v>8.6999999999999993</c:v>
                </c:pt>
                <c:pt idx="41">
                  <c:v>10.6</c:v>
                </c:pt>
                <c:pt idx="42">
                  <c:v>12.4</c:v>
                </c:pt>
                <c:pt idx="44">
                  <c:v>6.4</c:v>
                </c:pt>
                <c:pt idx="45">
                  <c:v>16.399999999999999</c:v>
                </c:pt>
                <c:pt idx="46">
                  <c:v>17.8</c:v>
                </c:pt>
                <c:pt idx="49">
                  <c:v>15.6</c:v>
                </c:pt>
                <c:pt idx="50">
                  <c:v>19.5</c:v>
                </c:pt>
                <c:pt idx="51">
                  <c:v>17.600000000000001</c:v>
                </c:pt>
                <c:pt idx="52">
                  <c:v>11.9</c:v>
                </c:pt>
                <c:pt idx="53">
                  <c:v>10.5</c:v>
                </c:pt>
                <c:pt idx="54">
                  <c:v>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4C6-4D9E-B10C-BE2283A7E1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9583104"/>
        <c:axId val="1899577824"/>
      </c:scatterChart>
      <c:valAx>
        <c:axId val="1899583104"/>
        <c:scaling>
          <c:orientation val="minMax"/>
          <c:max val="2500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noFill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1899577824"/>
        <c:crosses val="autoZero"/>
        <c:crossBetween val="midCat"/>
      </c:valAx>
      <c:valAx>
        <c:axId val="1899577824"/>
        <c:scaling>
          <c:orientation val="minMax"/>
          <c:max val="4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noFill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18995831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600">
          <a:latin typeface="Calibri" panose="020F0502020204030204" pitchFamily="34" charset="0"/>
          <a:ea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DKA!$BO$1</c:f>
              <c:strCache>
                <c:ptCount val="1"/>
                <c:pt idx="0">
                  <c:v>ｐ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DKA!$Z$2:$Z$40</c:f>
              <c:numCache>
                <c:formatCode>General</c:formatCode>
                <c:ptCount val="39"/>
                <c:pt idx="0">
                  <c:v>11506</c:v>
                </c:pt>
                <c:pt idx="1">
                  <c:v>13319</c:v>
                </c:pt>
                <c:pt idx="2">
                  <c:v>9871</c:v>
                </c:pt>
                <c:pt idx="3">
                  <c:v>9433</c:v>
                </c:pt>
                <c:pt idx="4">
                  <c:v>15964</c:v>
                </c:pt>
                <c:pt idx="5">
                  <c:v>13940</c:v>
                </c:pt>
                <c:pt idx="6">
                  <c:v>14942</c:v>
                </c:pt>
                <c:pt idx="7">
                  <c:v>10345</c:v>
                </c:pt>
                <c:pt idx="8">
                  <c:v>4928</c:v>
                </c:pt>
                <c:pt idx="9">
                  <c:v>10535</c:v>
                </c:pt>
                <c:pt idx="10">
                  <c:v>4133</c:v>
                </c:pt>
                <c:pt idx="11">
                  <c:v>14742</c:v>
                </c:pt>
                <c:pt idx="12">
                  <c:v>3837</c:v>
                </c:pt>
                <c:pt idx="13">
                  <c:v>6382</c:v>
                </c:pt>
                <c:pt idx="14">
                  <c:v>11005</c:v>
                </c:pt>
                <c:pt idx="15">
                  <c:v>16769</c:v>
                </c:pt>
                <c:pt idx="16">
                  <c:v>7833</c:v>
                </c:pt>
                <c:pt idx="17">
                  <c:v>3445</c:v>
                </c:pt>
                <c:pt idx="18">
                  <c:v>4288</c:v>
                </c:pt>
                <c:pt idx="19">
                  <c:v>23540</c:v>
                </c:pt>
                <c:pt idx="20">
                  <c:v>4459</c:v>
                </c:pt>
                <c:pt idx="21">
                  <c:v>14267</c:v>
                </c:pt>
                <c:pt idx="22">
                  <c:v>14546</c:v>
                </c:pt>
                <c:pt idx="23">
                  <c:v>15608</c:v>
                </c:pt>
                <c:pt idx="24">
                  <c:v>15253</c:v>
                </c:pt>
                <c:pt idx="25">
                  <c:v>15210</c:v>
                </c:pt>
                <c:pt idx="26">
                  <c:v>12434</c:v>
                </c:pt>
                <c:pt idx="27">
                  <c:v>15810</c:v>
                </c:pt>
                <c:pt idx="28">
                  <c:v>8908</c:v>
                </c:pt>
                <c:pt idx="29">
                  <c:v>16310</c:v>
                </c:pt>
                <c:pt idx="30">
                  <c:v>7436</c:v>
                </c:pt>
                <c:pt idx="31">
                  <c:v>14185</c:v>
                </c:pt>
                <c:pt idx="32">
                  <c:v>14565</c:v>
                </c:pt>
                <c:pt idx="33">
                  <c:v>20387</c:v>
                </c:pt>
                <c:pt idx="34">
                  <c:v>11280</c:v>
                </c:pt>
                <c:pt idx="35">
                  <c:v>13061</c:v>
                </c:pt>
                <c:pt idx="36">
                  <c:v>17871</c:v>
                </c:pt>
              </c:numCache>
            </c:numRef>
          </c:xVal>
          <c:yVal>
            <c:numRef>
              <c:f>DKA!$BS$2:$BS$40</c:f>
              <c:numCache>
                <c:formatCode>General</c:formatCode>
                <c:ptCount val="39"/>
                <c:pt idx="0">
                  <c:v>24.7</c:v>
                </c:pt>
                <c:pt idx="1">
                  <c:v>27</c:v>
                </c:pt>
                <c:pt idx="2">
                  <c:v>18.5</c:v>
                </c:pt>
                <c:pt idx="3">
                  <c:v>26.1</c:v>
                </c:pt>
                <c:pt idx="4">
                  <c:v>29.1</c:v>
                </c:pt>
                <c:pt idx="5">
                  <c:v>23.9</c:v>
                </c:pt>
                <c:pt idx="6">
                  <c:v>22.8</c:v>
                </c:pt>
                <c:pt idx="7">
                  <c:v>27.7</c:v>
                </c:pt>
                <c:pt idx="8">
                  <c:v>15.7</c:v>
                </c:pt>
                <c:pt idx="9">
                  <c:v>25.3</c:v>
                </c:pt>
                <c:pt idx="10">
                  <c:v>29.8</c:v>
                </c:pt>
                <c:pt idx="11">
                  <c:v>30</c:v>
                </c:pt>
                <c:pt idx="12">
                  <c:v>19.600000000000001</c:v>
                </c:pt>
                <c:pt idx="13">
                  <c:v>16.5</c:v>
                </c:pt>
                <c:pt idx="14">
                  <c:v>25.9</c:v>
                </c:pt>
                <c:pt idx="15">
                  <c:v>30.7</c:v>
                </c:pt>
                <c:pt idx="16">
                  <c:v>19.3</c:v>
                </c:pt>
                <c:pt idx="17">
                  <c:v>18.600000000000001</c:v>
                </c:pt>
                <c:pt idx="18">
                  <c:v>18.3</c:v>
                </c:pt>
                <c:pt idx="19">
                  <c:v>25.5</c:v>
                </c:pt>
                <c:pt idx="20">
                  <c:v>31.3</c:v>
                </c:pt>
                <c:pt idx="21">
                  <c:v>23</c:v>
                </c:pt>
                <c:pt idx="22">
                  <c:v>24.9</c:v>
                </c:pt>
                <c:pt idx="23">
                  <c:v>28.6</c:v>
                </c:pt>
                <c:pt idx="24">
                  <c:v>28.5</c:v>
                </c:pt>
                <c:pt idx="25">
                  <c:v>20.5</c:v>
                </c:pt>
                <c:pt idx="26">
                  <c:v>28.8</c:v>
                </c:pt>
                <c:pt idx="27">
                  <c:v>30.9</c:v>
                </c:pt>
                <c:pt idx="28">
                  <c:v>16.899999999999999</c:v>
                </c:pt>
                <c:pt idx="29">
                  <c:v>26</c:v>
                </c:pt>
                <c:pt idx="30">
                  <c:v>16.399999999999999</c:v>
                </c:pt>
                <c:pt idx="31">
                  <c:v>29.3</c:v>
                </c:pt>
                <c:pt idx="32">
                  <c:v>37.799999999999997</c:v>
                </c:pt>
                <c:pt idx="33">
                  <c:v>33.700000000000003</c:v>
                </c:pt>
                <c:pt idx="34">
                  <c:v>31.8</c:v>
                </c:pt>
                <c:pt idx="35">
                  <c:v>27.6</c:v>
                </c:pt>
                <c:pt idx="36">
                  <c:v>31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4DD-40F2-98F3-8C7B5A402C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9591744"/>
        <c:axId val="1899596544"/>
      </c:scatterChart>
      <c:valAx>
        <c:axId val="1899591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1899596544"/>
        <c:crosses val="autoZero"/>
        <c:crossBetween val="midCat"/>
      </c:valAx>
      <c:valAx>
        <c:axId val="18995965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18995917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600">
          <a:latin typeface="Calibri" panose="020F0502020204030204" pitchFamily="34" charset="0"/>
          <a:ea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DK!$BO$1</c:f>
              <c:strCache>
                <c:ptCount val="1"/>
                <c:pt idx="0">
                  <c:v>ｐH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K!$Z$2:$Z$93</c:f>
              <c:numCache>
                <c:formatCode>General</c:formatCode>
                <c:ptCount val="92"/>
                <c:pt idx="0">
                  <c:v>7177</c:v>
                </c:pt>
                <c:pt idx="2">
                  <c:v>3986</c:v>
                </c:pt>
                <c:pt idx="3">
                  <c:v>626</c:v>
                </c:pt>
                <c:pt idx="4">
                  <c:v>5705</c:v>
                </c:pt>
                <c:pt idx="5">
                  <c:v>3395</c:v>
                </c:pt>
                <c:pt idx="6">
                  <c:v>2105</c:v>
                </c:pt>
                <c:pt idx="7">
                  <c:v>2930</c:v>
                </c:pt>
                <c:pt idx="8">
                  <c:v>1409</c:v>
                </c:pt>
                <c:pt idx="9">
                  <c:v>815</c:v>
                </c:pt>
                <c:pt idx="10">
                  <c:v>972</c:v>
                </c:pt>
                <c:pt idx="11">
                  <c:v>2705</c:v>
                </c:pt>
                <c:pt idx="12">
                  <c:v>1327</c:v>
                </c:pt>
                <c:pt idx="13">
                  <c:v>5783</c:v>
                </c:pt>
                <c:pt idx="14">
                  <c:v>836</c:v>
                </c:pt>
                <c:pt idx="15">
                  <c:v>1159</c:v>
                </c:pt>
                <c:pt idx="16">
                  <c:v>820</c:v>
                </c:pt>
                <c:pt idx="17">
                  <c:v>1612</c:v>
                </c:pt>
                <c:pt idx="18">
                  <c:v>1011</c:v>
                </c:pt>
                <c:pt idx="19">
                  <c:v>152</c:v>
                </c:pt>
                <c:pt idx="20">
                  <c:v>6224</c:v>
                </c:pt>
                <c:pt idx="21">
                  <c:v>8524</c:v>
                </c:pt>
                <c:pt idx="22">
                  <c:v>738</c:v>
                </c:pt>
                <c:pt idx="23">
                  <c:v>6602</c:v>
                </c:pt>
                <c:pt idx="24">
                  <c:v>1411</c:v>
                </c:pt>
                <c:pt idx="25">
                  <c:v>12065</c:v>
                </c:pt>
                <c:pt idx="26">
                  <c:v>6866</c:v>
                </c:pt>
                <c:pt idx="27">
                  <c:v>323</c:v>
                </c:pt>
                <c:pt idx="28">
                  <c:v>411</c:v>
                </c:pt>
                <c:pt idx="29">
                  <c:v>4793</c:v>
                </c:pt>
                <c:pt idx="30">
                  <c:v>4667</c:v>
                </c:pt>
                <c:pt idx="31">
                  <c:v>5612</c:v>
                </c:pt>
                <c:pt idx="32">
                  <c:v>4928</c:v>
                </c:pt>
                <c:pt idx="33">
                  <c:v>10973</c:v>
                </c:pt>
                <c:pt idx="34">
                  <c:v>10605</c:v>
                </c:pt>
                <c:pt idx="35">
                  <c:v>2918</c:v>
                </c:pt>
                <c:pt idx="36">
                  <c:v>1145</c:v>
                </c:pt>
                <c:pt idx="37">
                  <c:v>6410</c:v>
                </c:pt>
                <c:pt idx="38">
                  <c:v>1415</c:v>
                </c:pt>
                <c:pt idx="39">
                  <c:v>893</c:v>
                </c:pt>
                <c:pt idx="40">
                  <c:v>1274</c:v>
                </c:pt>
                <c:pt idx="41">
                  <c:v>1817</c:v>
                </c:pt>
                <c:pt idx="42">
                  <c:v>9948</c:v>
                </c:pt>
                <c:pt idx="43">
                  <c:v>483</c:v>
                </c:pt>
                <c:pt idx="44">
                  <c:v>933</c:v>
                </c:pt>
                <c:pt idx="45">
                  <c:v>4265</c:v>
                </c:pt>
                <c:pt idx="46">
                  <c:v>7970</c:v>
                </c:pt>
                <c:pt idx="47">
                  <c:v>2485</c:v>
                </c:pt>
                <c:pt idx="48">
                  <c:v>6701</c:v>
                </c:pt>
                <c:pt idx="49">
                  <c:v>945</c:v>
                </c:pt>
                <c:pt idx="50">
                  <c:v>9700</c:v>
                </c:pt>
                <c:pt idx="51">
                  <c:v>7914</c:v>
                </c:pt>
                <c:pt idx="52">
                  <c:v>2660</c:v>
                </c:pt>
                <c:pt idx="53">
                  <c:v>720</c:v>
                </c:pt>
                <c:pt idx="54">
                  <c:v>13277</c:v>
                </c:pt>
              </c:numCache>
            </c:numRef>
          </c:xVal>
          <c:yVal>
            <c:numRef>
              <c:f>DK!$BO$2:$BO$93</c:f>
              <c:numCache>
                <c:formatCode>General</c:formatCode>
                <c:ptCount val="92"/>
                <c:pt idx="0">
                  <c:v>7.5110000000000001</c:v>
                </c:pt>
                <c:pt idx="2">
                  <c:v>7.4080000000000004</c:v>
                </c:pt>
                <c:pt idx="4">
                  <c:v>7.4269999999999996</c:v>
                </c:pt>
                <c:pt idx="5">
                  <c:v>7.3940000000000001</c:v>
                </c:pt>
                <c:pt idx="6">
                  <c:v>7.476</c:v>
                </c:pt>
                <c:pt idx="7">
                  <c:v>7.4059999999999997</c:v>
                </c:pt>
                <c:pt idx="8">
                  <c:v>7.423</c:v>
                </c:pt>
                <c:pt idx="9">
                  <c:v>7.423</c:v>
                </c:pt>
                <c:pt idx="10">
                  <c:v>7.3979999999999997</c:v>
                </c:pt>
                <c:pt idx="11">
                  <c:v>7.4009999999999998</c:v>
                </c:pt>
                <c:pt idx="12">
                  <c:v>7.452</c:v>
                </c:pt>
                <c:pt idx="13">
                  <c:v>7.3319999999999999</c:v>
                </c:pt>
                <c:pt idx="14">
                  <c:v>7.4349999999999996</c:v>
                </c:pt>
                <c:pt idx="15">
                  <c:v>7.3929999999999998</c:v>
                </c:pt>
                <c:pt idx="16">
                  <c:v>7.3760000000000003</c:v>
                </c:pt>
                <c:pt idx="17">
                  <c:v>7.4290000000000003</c:v>
                </c:pt>
                <c:pt idx="18">
                  <c:v>7.4029999999999996</c:v>
                </c:pt>
                <c:pt idx="19">
                  <c:v>7.4539999999999997</c:v>
                </c:pt>
                <c:pt idx="20">
                  <c:v>7.452</c:v>
                </c:pt>
                <c:pt idx="21">
                  <c:v>7.3840000000000003</c:v>
                </c:pt>
                <c:pt idx="22">
                  <c:v>7.415</c:v>
                </c:pt>
                <c:pt idx="23">
                  <c:v>7.4809999999999999</c:v>
                </c:pt>
                <c:pt idx="24">
                  <c:v>7.4450000000000003</c:v>
                </c:pt>
                <c:pt idx="25">
                  <c:v>7.3860000000000001</c:v>
                </c:pt>
                <c:pt idx="26">
                  <c:v>7.3879999999999999</c:v>
                </c:pt>
                <c:pt idx="27">
                  <c:v>7.3979999999999997</c:v>
                </c:pt>
                <c:pt idx="28">
                  <c:v>7.3570000000000002</c:v>
                </c:pt>
                <c:pt idx="29">
                  <c:v>7.516</c:v>
                </c:pt>
                <c:pt idx="30">
                  <c:v>7.3780000000000001</c:v>
                </c:pt>
                <c:pt idx="32">
                  <c:v>7.4550000000000001</c:v>
                </c:pt>
                <c:pt idx="33">
                  <c:v>7.3259999999999996</c:v>
                </c:pt>
                <c:pt idx="34">
                  <c:v>7.4119999999999999</c:v>
                </c:pt>
                <c:pt idx="35">
                  <c:v>7.4320000000000004</c:v>
                </c:pt>
                <c:pt idx="36">
                  <c:v>7.4560000000000004</c:v>
                </c:pt>
                <c:pt idx="37">
                  <c:v>7.4740000000000002</c:v>
                </c:pt>
                <c:pt idx="38">
                  <c:v>7.4379999999999997</c:v>
                </c:pt>
                <c:pt idx="39">
                  <c:v>7.3630000000000004</c:v>
                </c:pt>
                <c:pt idx="40">
                  <c:v>7.4589999999999996</c:v>
                </c:pt>
                <c:pt idx="41">
                  <c:v>7.4050000000000002</c:v>
                </c:pt>
                <c:pt idx="42">
                  <c:v>7.39</c:v>
                </c:pt>
                <c:pt idx="44">
                  <c:v>7.4569999999999999</c:v>
                </c:pt>
                <c:pt idx="45">
                  <c:v>7.4160000000000004</c:v>
                </c:pt>
                <c:pt idx="46">
                  <c:v>7.3769999999999998</c:v>
                </c:pt>
                <c:pt idx="49">
                  <c:v>7.4169999999999998</c:v>
                </c:pt>
                <c:pt idx="50">
                  <c:v>7.38</c:v>
                </c:pt>
                <c:pt idx="51">
                  <c:v>7.3250000000000002</c:v>
                </c:pt>
                <c:pt idx="52">
                  <c:v>7.4349999999999996</c:v>
                </c:pt>
                <c:pt idx="53">
                  <c:v>7.4080000000000004</c:v>
                </c:pt>
                <c:pt idx="54">
                  <c:v>7.32800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F97-4799-9960-C03AEB9592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0009672"/>
        <c:axId val="600013992"/>
      </c:scatterChart>
      <c:valAx>
        <c:axId val="600009672"/>
        <c:scaling>
          <c:orientation val="minMax"/>
          <c:max val="2500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noFill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600013992"/>
        <c:crosses val="autoZero"/>
        <c:crossBetween val="midCat"/>
      </c:valAx>
      <c:valAx>
        <c:axId val="600013992"/>
        <c:scaling>
          <c:orientation val="minMax"/>
          <c:max val="7.6"/>
          <c:min val="6.7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noFill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6000096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600">
          <a:latin typeface="Calibri" panose="020F0502020204030204" pitchFamily="34" charset="0"/>
          <a:ea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DKA!$BO$1</c:f>
              <c:strCache>
                <c:ptCount val="1"/>
                <c:pt idx="0">
                  <c:v>ｐH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DKA!$Z$2:$Z$93</c:f>
              <c:numCache>
                <c:formatCode>General</c:formatCode>
                <c:ptCount val="92"/>
                <c:pt idx="0">
                  <c:v>11506</c:v>
                </c:pt>
                <c:pt idx="1">
                  <c:v>13319</c:v>
                </c:pt>
                <c:pt idx="2">
                  <c:v>9871</c:v>
                </c:pt>
                <c:pt idx="3">
                  <c:v>9433</c:v>
                </c:pt>
                <c:pt idx="4">
                  <c:v>15964</c:v>
                </c:pt>
                <c:pt idx="5">
                  <c:v>13940</c:v>
                </c:pt>
                <c:pt idx="6">
                  <c:v>14942</c:v>
                </c:pt>
                <c:pt idx="7">
                  <c:v>10345</c:v>
                </c:pt>
                <c:pt idx="8">
                  <c:v>4928</c:v>
                </c:pt>
                <c:pt idx="9">
                  <c:v>10535</c:v>
                </c:pt>
                <c:pt idx="10">
                  <c:v>4133</c:v>
                </c:pt>
                <c:pt idx="11">
                  <c:v>14742</c:v>
                </c:pt>
                <c:pt idx="12">
                  <c:v>3837</c:v>
                </c:pt>
                <c:pt idx="13">
                  <c:v>6382</c:v>
                </c:pt>
                <c:pt idx="14">
                  <c:v>11005</c:v>
                </c:pt>
                <c:pt idx="15">
                  <c:v>16769</c:v>
                </c:pt>
                <c:pt idx="16">
                  <c:v>7833</c:v>
                </c:pt>
                <c:pt idx="17">
                  <c:v>3445</c:v>
                </c:pt>
                <c:pt idx="18">
                  <c:v>4288</c:v>
                </c:pt>
                <c:pt idx="19">
                  <c:v>23540</c:v>
                </c:pt>
                <c:pt idx="20">
                  <c:v>4459</c:v>
                </c:pt>
                <c:pt idx="21">
                  <c:v>14267</c:v>
                </c:pt>
                <c:pt idx="22">
                  <c:v>14546</c:v>
                </c:pt>
                <c:pt idx="23">
                  <c:v>15608</c:v>
                </c:pt>
                <c:pt idx="24">
                  <c:v>15253</c:v>
                </c:pt>
                <c:pt idx="25">
                  <c:v>15210</c:v>
                </c:pt>
                <c:pt idx="26">
                  <c:v>12434</c:v>
                </c:pt>
                <c:pt idx="27">
                  <c:v>15810</c:v>
                </c:pt>
                <c:pt idx="28">
                  <c:v>8908</c:v>
                </c:pt>
                <c:pt idx="29">
                  <c:v>16310</c:v>
                </c:pt>
                <c:pt idx="30">
                  <c:v>7436</c:v>
                </c:pt>
                <c:pt idx="31">
                  <c:v>14185</c:v>
                </c:pt>
                <c:pt idx="32">
                  <c:v>14565</c:v>
                </c:pt>
                <c:pt idx="33">
                  <c:v>20387</c:v>
                </c:pt>
                <c:pt idx="34">
                  <c:v>11280</c:v>
                </c:pt>
                <c:pt idx="35">
                  <c:v>13061</c:v>
                </c:pt>
                <c:pt idx="36">
                  <c:v>17871</c:v>
                </c:pt>
              </c:numCache>
            </c:numRef>
          </c:xVal>
          <c:yVal>
            <c:numRef>
              <c:f>DKA!$BO$2:$BO$93</c:f>
              <c:numCache>
                <c:formatCode>General</c:formatCode>
                <c:ptCount val="92"/>
                <c:pt idx="0">
                  <c:v>7.1589999999999998</c:v>
                </c:pt>
                <c:pt idx="1">
                  <c:v>6.8650000000000002</c:v>
                </c:pt>
                <c:pt idx="2">
                  <c:v>7.17</c:v>
                </c:pt>
                <c:pt idx="3">
                  <c:v>7.2990000000000004</c:v>
                </c:pt>
                <c:pt idx="4">
                  <c:v>7.1289999999999996</c:v>
                </c:pt>
                <c:pt idx="5">
                  <c:v>6.9210000000000003</c:v>
                </c:pt>
                <c:pt idx="6">
                  <c:v>7.008</c:v>
                </c:pt>
                <c:pt idx="7">
                  <c:v>7.1849999999999996</c:v>
                </c:pt>
                <c:pt idx="8">
                  <c:v>7.2759999999999998</c:v>
                </c:pt>
                <c:pt idx="9">
                  <c:v>7.2539999999999996</c:v>
                </c:pt>
                <c:pt idx="10">
                  <c:v>7.1920000000000002</c:v>
                </c:pt>
                <c:pt idx="11">
                  <c:v>7.2160000000000002</c:v>
                </c:pt>
                <c:pt idx="12">
                  <c:v>7.2590000000000003</c:v>
                </c:pt>
                <c:pt idx="13">
                  <c:v>7.2869999999999999</c:v>
                </c:pt>
                <c:pt idx="14">
                  <c:v>7.298</c:v>
                </c:pt>
                <c:pt idx="15">
                  <c:v>7.0060000000000002</c:v>
                </c:pt>
                <c:pt idx="16">
                  <c:v>7.2949999999999999</c:v>
                </c:pt>
                <c:pt idx="17">
                  <c:v>7.2850000000000001</c:v>
                </c:pt>
                <c:pt idx="18">
                  <c:v>7.2850000000000001</c:v>
                </c:pt>
                <c:pt idx="19">
                  <c:v>7.2930000000000001</c:v>
                </c:pt>
                <c:pt idx="20">
                  <c:v>7.2569999999999997</c:v>
                </c:pt>
                <c:pt idx="21">
                  <c:v>7.29</c:v>
                </c:pt>
                <c:pt idx="22">
                  <c:v>7.2709999999999999</c:v>
                </c:pt>
                <c:pt idx="23">
                  <c:v>7.27</c:v>
                </c:pt>
                <c:pt idx="24">
                  <c:v>7.024</c:v>
                </c:pt>
                <c:pt idx="25">
                  <c:v>7.2519999999999998</c:v>
                </c:pt>
                <c:pt idx="26">
                  <c:v>7.1609999999999996</c:v>
                </c:pt>
                <c:pt idx="27">
                  <c:v>7.0369999999999999</c:v>
                </c:pt>
                <c:pt idx="28">
                  <c:v>7.2190000000000003</c:v>
                </c:pt>
                <c:pt idx="29">
                  <c:v>7.1879999999999997</c:v>
                </c:pt>
                <c:pt idx="30">
                  <c:v>7.266</c:v>
                </c:pt>
                <c:pt idx="31">
                  <c:v>7.1459999999999999</c:v>
                </c:pt>
                <c:pt idx="32">
                  <c:v>7.1609999999999996</c:v>
                </c:pt>
                <c:pt idx="33">
                  <c:v>7.1769999999999996</c:v>
                </c:pt>
                <c:pt idx="34">
                  <c:v>7.1369999999999996</c:v>
                </c:pt>
                <c:pt idx="35">
                  <c:v>6.82</c:v>
                </c:pt>
                <c:pt idx="36">
                  <c:v>7.128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D95-4A4B-B1FF-B9EED86227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9621952"/>
        <c:axId val="459619072"/>
      </c:scatterChart>
      <c:valAx>
        <c:axId val="459621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459619072"/>
        <c:crosses val="autoZero"/>
        <c:crossBetween val="midCat"/>
      </c:valAx>
      <c:valAx>
        <c:axId val="459619072"/>
        <c:scaling>
          <c:orientation val="minMax"/>
          <c:max val="7.6"/>
          <c:min val="6.7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ja-JP"/>
          </a:p>
        </c:txPr>
        <c:crossAx val="4596219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600">
          <a:latin typeface="Calibri" panose="020F0502020204030204" pitchFamily="34" charset="0"/>
          <a:ea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A8FF4C-EF80-2C33-85AF-9B6518A28E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37F00A5-163F-665C-DE80-984E54FC1A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85DF6A-81AB-4B78-71D7-025359B59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1326D5-BE05-6EA3-0397-3B810D9C4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AE7838-8F38-5923-9169-A2EA917FE8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7167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F2A55A-88E2-8BB3-1E24-B986010910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C79A6FF-58E8-72CD-0EA6-56A908B7C0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830A24F-5383-18A7-4735-0A96F5C5B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C10B6FD-B990-2866-BF51-4D3A3A9CF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9665C9F-12FF-2784-C254-50A77065A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9774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F9BE0BD-5DB0-62CA-0FF4-F542FE1F2F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299DF15-F03A-4FE3-32CF-38CF446236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8EC5DCB-A09E-63C5-B547-24FDBDBD9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36CEB0-EC2F-A894-A2AD-AB2B36FE8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B76C49-BD8C-A091-B761-04D479467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5811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57941B-9BEB-6D2D-C77B-4A088AA5AF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BCEF2BE-8C5D-C7F6-CF5C-A859AB34F5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C4C4A4-C7D8-B114-9E49-BDC402EE1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FD9FCF-80A0-8B2B-14E0-4C4772BCC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31681B-400A-6680-B456-D9F09C815B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3054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8595DB-BF59-63B8-9960-70B6E1F8E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6AC5125-C326-FFC0-DDB9-E385ACBF04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293593-6567-6ABC-3E5D-87B1E1F9F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2E8058-EDBE-9253-6D24-CCD4EE627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AF01C8-031D-2817-3B90-9AA0D6637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1903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CB3D67-370F-60F2-6B3D-F88592BAA2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69F7BE-668C-7327-C087-5556DFF6FA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3266A52-49E3-5C28-12AB-35628DD981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B5F117F-6094-44EC-D9E7-7BACB595D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1CA090A-E904-9A51-A171-FFF3C34EE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562B15A-1EEB-7AA2-A1A4-EB96B8634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623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5EC110-8E6C-58C7-EB0A-B029C38118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35F96D3-4E84-61F3-F255-DC90C557EC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39CFE46-AD2B-09C7-0EF3-D675A4E6DE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7BD128E-062B-CC6F-C1DA-0A91E5D1D6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87109F0-9D36-118C-7F7D-47A07E31FE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F3809E3-29FA-F7F8-6A15-B0547209E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383FCFA-486B-A8B9-4B7A-4A36A6E83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345E7EF-41AC-BE0D-57CC-E807BA9B8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4903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3106A1-3B71-F189-5E99-FE8DE0773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AEAB836-9978-C027-E1C3-8BE4A33B9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A3B21CC-4707-79DE-14E9-E39794597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83C21F3-E5A0-66D6-2E82-A75CEEBDA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0192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E06DE29-E276-8805-98F2-536C2CB5A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24C5B72-0E5C-B6A2-21DB-314467284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A86A3A1-926A-395A-24F8-223D17AE6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0178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5B9613-434E-3B5F-9A7D-0AE117E7F8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0B29EEB-F0B5-57C7-1AB7-4510789B2A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C776470-7DF7-439F-D7FB-8AFB1E8E1E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609296C-D122-39AF-34E1-2DBFC05681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88C58ED-2F34-88BB-4572-C5A9B210B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D4C345-001D-A099-4CA3-576E6EDFF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641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2B8E70-6EBD-C609-1C4C-21E104EE98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CBB0DC5-5749-D3CF-8584-B6B53094DF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6D732EE-F7F6-5294-B838-2D4C9BCFCF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487423F-C782-5425-4F96-DEACE4E5A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93D25E8-AD2A-F004-99ED-4EFD789DD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DDC427-8BE4-5E38-5934-5A5DCF203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0698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6D5EEC2-C8D5-A2DE-2E72-6AA663F41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36409F8-5D73-5783-C2CD-EFFE60FDF6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78BCA7-AF26-61F5-125E-2119E2A8EF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1DBA37-8E22-4389-A54A-0E6F4EB4CE8C}" type="datetimeFigureOut">
              <a:rPr kumimoji="1" lang="ja-JP" altLang="en-US" smtClean="0"/>
              <a:t>2025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2D5611-E34E-4910-393E-B7C2F836C9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63C518-F07F-870C-5123-0E04184B35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959145-BEC6-465B-94F6-13DA4C9D6B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781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9C086D2-F683-154F-AC82-3C419EAA5C08}"/>
              </a:ext>
            </a:extLst>
          </p:cNvPr>
          <p:cNvSpPr txBox="1"/>
          <p:nvPr/>
        </p:nvSpPr>
        <p:spPr>
          <a:xfrm>
            <a:off x="657219" y="400194"/>
            <a:ext cx="2562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kumimoji="1" lang="ja-JP" alt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C855E7F-A8D9-E0BA-FBEE-F03FCBAD9C4E}"/>
              </a:ext>
            </a:extLst>
          </p:cNvPr>
          <p:cNvSpPr txBox="1"/>
          <p:nvPr/>
        </p:nvSpPr>
        <p:spPr>
          <a:xfrm>
            <a:off x="464135" y="984725"/>
            <a:ext cx="6834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H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35DE69B-C92A-957D-25C8-7142A09ECA5D}"/>
              </a:ext>
            </a:extLst>
          </p:cNvPr>
          <p:cNvSpPr txBox="1"/>
          <p:nvPr/>
        </p:nvSpPr>
        <p:spPr>
          <a:xfrm>
            <a:off x="3575046" y="1293112"/>
            <a:ext cx="2327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ρ=-0.71,</a:t>
            </a:r>
            <a:r>
              <a:rPr lang="ja-JP" alt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&lt;0.0001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1150F18E-DAFF-9C8E-AB6A-FFBF19073047}"/>
              </a:ext>
            </a:extLst>
          </p:cNvPr>
          <p:cNvGrpSpPr/>
          <p:nvPr/>
        </p:nvGrpSpPr>
        <p:grpSpPr>
          <a:xfrm>
            <a:off x="536278" y="4267204"/>
            <a:ext cx="5366332" cy="2314437"/>
            <a:chOff x="3575046" y="3500594"/>
            <a:chExt cx="4572000" cy="2750115"/>
          </a:xfrm>
        </p:grpSpPr>
        <p:graphicFrame>
          <p:nvGraphicFramePr>
            <p:cNvPr id="12" name="グラフ 11">
              <a:extLst>
                <a:ext uri="{FF2B5EF4-FFF2-40B4-BE49-F238E27FC236}">
                  <a16:creationId xmlns:a16="http://schemas.microsoft.com/office/drawing/2014/main" id="{33A4C463-9DFF-FC65-ABB5-CA735599579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02177212"/>
                </p:ext>
              </p:extLst>
            </p:nvPr>
          </p:nvGraphicFramePr>
          <p:xfrm>
            <a:off x="3575046" y="3507509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3" name="グラフ 12">
              <a:extLst>
                <a:ext uri="{FF2B5EF4-FFF2-40B4-BE49-F238E27FC236}">
                  <a16:creationId xmlns:a16="http://schemas.microsoft.com/office/drawing/2014/main" id="{056DA41A-EB3C-A1F3-B6D5-C08BB5B8D08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36391892"/>
                </p:ext>
              </p:extLst>
            </p:nvPr>
          </p:nvGraphicFramePr>
          <p:xfrm>
            <a:off x="3575046" y="3500594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BF1B844-BABB-7435-D229-9C4AD158E2CA}"/>
              </a:ext>
            </a:extLst>
          </p:cNvPr>
          <p:cNvSpPr txBox="1"/>
          <p:nvPr/>
        </p:nvSpPr>
        <p:spPr>
          <a:xfrm>
            <a:off x="410720" y="3869052"/>
            <a:ext cx="128316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carbornate</a:t>
            </a:r>
            <a:endParaRPr kumimoji="1" lang="en-US" altLang="ja-JP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kumimoji="1" lang="en-US" altLang="ja-JP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q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L)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679867B-6050-6FAC-5266-DA7F91F4BD10}"/>
              </a:ext>
            </a:extLst>
          </p:cNvPr>
          <p:cNvSpPr txBox="1"/>
          <p:nvPr/>
        </p:nvSpPr>
        <p:spPr>
          <a:xfrm>
            <a:off x="3588903" y="4521220"/>
            <a:ext cx="2327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ρ=-0.88,</a:t>
            </a:r>
            <a:r>
              <a:rPr lang="ja-JP" alt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&lt;0.0001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411C6F44-03A6-DAE7-2C3C-90027B70092F}"/>
              </a:ext>
            </a:extLst>
          </p:cNvPr>
          <p:cNvGrpSpPr/>
          <p:nvPr/>
        </p:nvGrpSpPr>
        <p:grpSpPr>
          <a:xfrm>
            <a:off x="6096000" y="1290431"/>
            <a:ext cx="5459269" cy="2314437"/>
            <a:chOff x="6590145" y="967671"/>
            <a:chExt cx="4572001" cy="2744883"/>
          </a:xfrm>
        </p:grpSpPr>
        <p:graphicFrame>
          <p:nvGraphicFramePr>
            <p:cNvPr id="18" name="グラフ 17">
              <a:extLst>
                <a:ext uri="{FF2B5EF4-FFF2-40B4-BE49-F238E27FC236}">
                  <a16:creationId xmlns:a16="http://schemas.microsoft.com/office/drawing/2014/main" id="{33A4C463-9DFF-FC65-ABB5-CA735599579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90769243"/>
                </p:ext>
              </p:extLst>
            </p:nvPr>
          </p:nvGraphicFramePr>
          <p:xfrm>
            <a:off x="6590146" y="967671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9" name="グラフ 18">
              <a:extLst>
                <a:ext uri="{FF2B5EF4-FFF2-40B4-BE49-F238E27FC236}">
                  <a16:creationId xmlns:a16="http://schemas.microsoft.com/office/drawing/2014/main" id="{056DA41A-EB3C-A1F3-B6D5-C08BB5B8D08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7785694"/>
                </p:ext>
              </p:extLst>
            </p:nvPr>
          </p:nvGraphicFramePr>
          <p:xfrm>
            <a:off x="6590145" y="969354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1278AB6-6775-D95D-AAE7-CFF692EA7465}"/>
              </a:ext>
            </a:extLst>
          </p:cNvPr>
          <p:cNvSpPr txBox="1"/>
          <p:nvPr/>
        </p:nvSpPr>
        <p:spPr>
          <a:xfrm>
            <a:off x="6024431" y="721450"/>
            <a:ext cx="9149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G</a:t>
            </a:r>
          </a:p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kumimoji="1" lang="en-US" altLang="ja-JP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q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L)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6CC07AA-EF55-F924-0AF1-E965754DA033}"/>
              </a:ext>
            </a:extLst>
          </p:cNvPr>
          <p:cNvSpPr txBox="1"/>
          <p:nvPr/>
        </p:nvSpPr>
        <p:spPr>
          <a:xfrm>
            <a:off x="9851170" y="1297733"/>
            <a:ext cx="2327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ρ=0.82,</a:t>
            </a:r>
            <a:r>
              <a:rPr lang="ja-JP" alt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&lt;0.0001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223D7589-5487-78B2-CF4D-EA63FDC8D427}"/>
              </a:ext>
            </a:extLst>
          </p:cNvPr>
          <p:cNvGrpSpPr/>
          <p:nvPr/>
        </p:nvGrpSpPr>
        <p:grpSpPr>
          <a:xfrm>
            <a:off x="464708" y="1264053"/>
            <a:ext cx="5366905" cy="2316156"/>
            <a:chOff x="-4507341" y="-515424"/>
            <a:chExt cx="5366905" cy="2316156"/>
          </a:xfrm>
        </p:grpSpPr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71987DF3-5794-4F02-C913-21D688410AE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41880935"/>
                </p:ext>
              </p:extLst>
            </p:nvPr>
          </p:nvGraphicFramePr>
          <p:xfrm>
            <a:off x="-4507341" y="-515424"/>
            <a:ext cx="5366332" cy="23161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グラフ 6">
              <a:extLst>
                <a:ext uri="{FF2B5EF4-FFF2-40B4-BE49-F238E27FC236}">
                  <a16:creationId xmlns:a16="http://schemas.microsoft.com/office/drawing/2014/main" id="{3FED173A-3E04-39D2-0F82-FEB19F7A72A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05302626"/>
                </p:ext>
              </p:extLst>
            </p:nvPr>
          </p:nvGraphicFramePr>
          <p:xfrm>
            <a:off x="-4506768" y="-515424"/>
            <a:ext cx="5366332" cy="23086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459573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36</Words>
  <Application>Microsoft Office PowerPoint</Application>
  <PresentationFormat>ワイド画面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飯田 達也</dc:creator>
  <cp:lastModifiedBy>飯田 達也</cp:lastModifiedBy>
  <cp:revision>7</cp:revision>
  <dcterms:created xsi:type="dcterms:W3CDTF">2025-10-01T05:27:34Z</dcterms:created>
  <dcterms:modified xsi:type="dcterms:W3CDTF">2025-10-08T05:42:38Z</dcterms:modified>
</cp:coreProperties>
</file>